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6"/>
  </p:notesMasterIdLst>
  <p:sldIdLst>
    <p:sldId id="267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D6BFA2E-F172-2556-00E4-1D2C5CEC1308}" name="Sara Wienke" initials="SW" userId="S::swienke@guardanthealth.com::44f54943-3314-470e-928b-597200c85ffe" providerId="AD"/>
  <p188:author id="{1241055D-7DF1-DB9D-7BCF-C5A38B4AA1EF}" name="Jude Masannat" initials="JM" userId="S::jmasannat@guardanthealth.com::48affbf4-8ab1-4fc4-82db-3208965ad05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310"/>
    <p:restoredTop sz="94558"/>
  </p:normalViewPr>
  <p:slideViewPr>
    <p:cSldViewPr snapToGrid="0">
      <p:cViewPr varScale="1">
        <p:scale>
          <a:sx n="90" d="100"/>
          <a:sy n="90" d="100"/>
        </p:scale>
        <p:origin x="3224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8/10/relationships/authors" Target="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313F00-949A-7A41-BA11-E8DECFFB2187}" type="datetimeFigureOut">
              <a:rPr lang="en-US" smtClean="0"/>
              <a:t>7/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333865-40B2-6249-89FB-0719449F8D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3972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7D454B0-9491-E543-919A-7D5320A4024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3062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295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554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425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696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738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285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156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282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270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571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33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653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emf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10" Type="http://schemas.openxmlformats.org/officeDocument/2006/relationships/image" Target="../media/image8.emf"/><Relationship Id="rId4" Type="http://schemas.openxmlformats.org/officeDocument/2006/relationships/image" Target="../media/image2.jpe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A55EDF45-5ADC-57DA-39E9-5FBD396E13F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4463" y="569755"/>
            <a:ext cx="2994537" cy="1987678"/>
          </a:xfrm>
          <a:prstGeom prst="rect">
            <a:avLst/>
          </a:prstGeom>
        </p:spPr>
      </p:pic>
      <p:pic>
        <p:nvPicPr>
          <p:cNvPr id="3" name="Picture 2" descr="A graph of a number of months&#10;&#10;Description automatically generated with medium confidence">
            <a:extLst>
              <a:ext uri="{FF2B5EF4-FFF2-40B4-BE49-F238E27FC236}">
                <a16:creationId xmlns:a16="http://schemas.microsoft.com/office/drawing/2014/main" id="{77642C69-EF3F-F334-D31E-0AA8C9F59AE6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-1" r="20503"/>
          <a:stretch/>
        </p:blipFill>
        <p:spPr>
          <a:xfrm>
            <a:off x="1042979" y="2753623"/>
            <a:ext cx="2298897" cy="1987678"/>
          </a:xfrm>
          <a:prstGeom prst="rect">
            <a:avLst/>
          </a:prstGeom>
        </p:spPr>
      </p:pic>
      <p:pic>
        <p:nvPicPr>
          <p:cNvPr id="6" name="Picture 5" descr="A graph showing the number of months and months&#10;&#10;Description automatically generated">
            <a:extLst>
              <a:ext uri="{FF2B5EF4-FFF2-40B4-BE49-F238E27FC236}">
                <a16:creationId xmlns:a16="http://schemas.microsoft.com/office/drawing/2014/main" id="{2CEA0800-C408-F5AD-591C-23B522DBCF1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16125" y="2753623"/>
            <a:ext cx="2891808" cy="1987678"/>
          </a:xfrm>
          <a:prstGeom prst="rect">
            <a:avLst/>
          </a:prstGeom>
        </p:spPr>
      </p:pic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674B55BE-7EB3-E72C-5270-C5E09E2ED763}"/>
              </a:ext>
            </a:extLst>
          </p:cNvPr>
          <p:cNvGraphicFramePr>
            <a:graphicFrameLocks noGrp="1"/>
          </p:cNvGraphicFramePr>
          <p:nvPr/>
        </p:nvGraphicFramePr>
        <p:xfrm>
          <a:off x="702484" y="4731842"/>
          <a:ext cx="2726517" cy="49167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13314">
                  <a:extLst>
                    <a:ext uri="{9D8B030D-6E8A-4147-A177-3AD203B41FA5}">
                      <a16:colId xmlns:a16="http://schemas.microsoft.com/office/drawing/2014/main" val="1922820846"/>
                    </a:ext>
                  </a:extLst>
                </a:gridCol>
                <a:gridCol w="462641">
                  <a:extLst>
                    <a:ext uri="{9D8B030D-6E8A-4147-A177-3AD203B41FA5}">
                      <a16:colId xmlns:a16="http://schemas.microsoft.com/office/drawing/2014/main" val="465163190"/>
                    </a:ext>
                  </a:extLst>
                </a:gridCol>
                <a:gridCol w="460064">
                  <a:extLst>
                    <a:ext uri="{9D8B030D-6E8A-4147-A177-3AD203B41FA5}">
                      <a16:colId xmlns:a16="http://schemas.microsoft.com/office/drawing/2014/main" val="3655331833"/>
                    </a:ext>
                  </a:extLst>
                </a:gridCol>
                <a:gridCol w="454052">
                  <a:extLst>
                    <a:ext uri="{9D8B030D-6E8A-4147-A177-3AD203B41FA5}">
                      <a16:colId xmlns:a16="http://schemas.microsoft.com/office/drawing/2014/main" val="2196137250"/>
                    </a:ext>
                  </a:extLst>
                </a:gridCol>
                <a:gridCol w="462142">
                  <a:extLst>
                    <a:ext uri="{9D8B030D-6E8A-4147-A177-3AD203B41FA5}">
                      <a16:colId xmlns:a16="http://schemas.microsoft.com/office/drawing/2014/main" val="1925397245"/>
                    </a:ext>
                  </a:extLst>
                </a:gridCol>
                <a:gridCol w="474304">
                  <a:extLst>
                    <a:ext uri="{9D8B030D-6E8A-4147-A177-3AD203B41FA5}">
                      <a16:colId xmlns:a16="http://schemas.microsoft.com/office/drawing/2014/main" val="1689343478"/>
                    </a:ext>
                  </a:extLst>
                </a:gridCol>
              </a:tblGrid>
              <a:tr h="21735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>
                          <a:effectLst/>
                        </a:rPr>
                        <a:t>TF Bin </a:t>
                      </a:r>
                      <a:endParaRPr lang="en-US" sz="400" b="0" i="0">
                        <a:effectLst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 i="0">
                          <a:effectLst/>
                        </a:rPr>
                        <a:t>Below LOQ (&lt;0.01%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 i="0">
                          <a:effectLst/>
                        </a:rPr>
                        <a:t>1</a:t>
                      </a:r>
                      <a:r>
                        <a:rPr lang="en-US" sz="400" b="0" i="0" baseline="30000">
                          <a:effectLst/>
                        </a:rPr>
                        <a:t>st</a:t>
                      </a:r>
                      <a:r>
                        <a:rPr lang="en-US" sz="400" b="0" i="0">
                          <a:effectLst/>
                        </a:rPr>
                        <a:t> Quartile </a:t>
                      </a:r>
                    </a:p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 i="0">
                          <a:effectLst/>
                        </a:rPr>
                        <a:t>(0.18%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 i="0">
                          <a:effectLst/>
                        </a:rPr>
                        <a:t>2</a:t>
                      </a:r>
                      <a:r>
                        <a:rPr lang="en-US" sz="400" b="0" i="0" baseline="30000">
                          <a:effectLst/>
                        </a:rPr>
                        <a:t>nd</a:t>
                      </a:r>
                      <a:r>
                        <a:rPr lang="en-US" sz="400" b="0" i="0">
                          <a:effectLst/>
                        </a:rPr>
                        <a:t> Quartile </a:t>
                      </a:r>
                    </a:p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 i="0">
                          <a:effectLst/>
                        </a:rPr>
                        <a:t>(1.29%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 i="0">
                          <a:effectLst/>
                        </a:rPr>
                        <a:t>3</a:t>
                      </a:r>
                      <a:r>
                        <a:rPr lang="en-US" sz="400" b="0" i="0" baseline="30000">
                          <a:effectLst/>
                        </a:rPr>
                        <a:t>rd</a:t>
                      </a:r>
                      <a:r>
                        <a:rPr lang="en-US" sz="400" b="0" i="0">
                          <a:effectLst/>
                        </a:rPr>
                        <a:t> Quartile </a:t>
                      </a:r>
                    </a:p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 i="0">
                          <a:effectLst/>
                        </a:rPr>
                        <a:t>(10.21%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 i="0">
                          <a:effectLst/>
                        </a:rPr>
                        <a:t>4</a:t>
                      </a:r>
                      <a:r>
                        <a:rPr lang="en-US" sz="400" b="0" i="0" baseline="30000">
                          <a:effectLst/>
                        </a:rPr>
                        <a:t>th</a:t>
                      </a:r>
                      <a:r>
                        <a:rPr lang="en-US" sz="400" b="0" i="0">
                          <a:effectLst/>
                        </a:rPr>
                        <a:t> Quartile (90.00%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2812678"/>
                  </a:ext>
                </a:extLst>
              </a:tr>
              <a:tr h="246717">
                <a:tc>
                  <a:txBody>
                    <a:bodyPr/>
                    <a:lstStyle/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>
                          <a:effectLst/>
                        </a:rPr>
                        <a:t>Median rwPFS (95% CI)</a:t>
                      </a:r>
                      <a:endParaRPr lang="en-US" sz="400" b="0" i="0">
                        <a:effectLst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>
                          <a:effectLst/>
                        </a:rPr>
                        <a:t>NR </a:t>
                      </a:r>
                    </a:p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>
                          <a:effectLst/>
                        </a:rPr>
                        <a:t>[ NR,NR] </a:t>
                      </a:r>
                      <a:endParaRPr lang="en-US" sz="400" b="0" i="0">
                        <a:effectLst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400" b="0">
                          <a:effectLst/>
                        </a:rPr>
                        <a:t>14.27 </a:t>
                      </a:r>
                    </a:p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400" b="0">
                          <a:effectLst/>
                        </a:rPr>
                        <a:t>[ 9.33,NR] </a:t>
                      </a:r>
                      <a:endParaRPr lang="en-US" sz="400" b="0" i="0">
                        <a:effectLst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400" b="0">
                          <a:effectLst/>
                        </a:rPr>
                        <a:t>8.77 </a:t>
                      </a:r>
                    </a:p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400" b="0">
                          <a:effectLst/>
                        </a:rPr>
                        <a:t>[7.00,12.13]</a:t>
                      </a:r>
                      <a:endParaRPr lang="en-US" sz="400" b="0" i="0">
                        <a:effectLst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400" b="0">
                          <a:effectLst/>
                        </a:rPr>
                        <a:t>6.23 </a:t>
                      </a:r>
                    </a:p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400" b="0">
                          <a:effectLst/>
                        </a:rPr>
                        <a:t>[5.13,8.67]</a:t>
                      </a:r>
                      <a:endParaRPr lang="en-US" sz="400" b="0" i="0">
                        <a:effectLst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400" b="0">
                          <a:effectLst/>
                        </a:rPr>
                        <a:t>5.3 </a:t>
                      </a:r>
                    </a:p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400" b="0">
                          <a:effectLst/>
                        </a:rPr>
                        <a:t>[4.5,6.80] </a:t>
                      </a:r>
                      <a:endParaRPr lang="en-US" sz="400" b="0" i="0">
                        <a:effectLst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8800230"/>
                  </a:ext>
                </a:extLst>
              </a:tr>
            </a:tbl>
          </a:graphicData>
        </a:graphic>
      </p:graphicFrame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93967B3E-8CBB-D80B-BA91-22559A5C159B}"/>
              </a:ext>
            </a:extLst>
          </p:cNvPr>
          <p:cNvGraphicFramePr>
            <a:graphicFrameLocks noGrp="1"/>
          </p:cNvGraphicFramePr>
          <p:nvPr/>
        </p:nvGraphicFramePr>
        <p:xfrm>
          <a:off x="3527982" y="4725512"/>
          <a:ext cx="2726515" cy="4876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32814">
                  <a:extLst>
                    <a:ext uri="{9D8B030D-6E8A-4147-A177-3AD203B41FA5}">
                      <a16:colId xmlns:a16="http://schemas.microsoft.com/office/drawing/2014/main" val="1922820846"/>
                    </a:ext>
                  </a:extLst>
                </a:gridCol>
                <a:gridCol w="471405">
                  <a:extLst>
                    <a:ext uri="{9D8B030D-6E8A-4147-A177-3AD203B41FA5}">
                      <a16:colId xmlns:a16="http://schemas.microsoft.com/office/drawing/2014/main" val="465163190"/>
                    </a:ext>
                  </a:extLst>
                </a:gridCol>
                <a:gridCol w="450297">
                  <a:extLst>
                    <a:ext uri="{9D8B030D-6E8A-4147-A177-3AD203B41FA5}">
                      <a16:colId xmlns:a16="http://schemas.microsoft.com/office/drawing/2014/main" val="3655331833"/>
                    </a:ext>
                  </a:extLst>
                </a:gridCol>
                <a:gridCol w="446717">
                  <a:extLst>
                    <a:ext uri="{9D8B030D-6E8A-4147-A177-3AD203B41FA5}">
                      <a16:colId xmlns:a16="http://schemas.microsoft.com/office/drawing/2014/main" val="2196137250"/>
                    </a:ext>
                  </a:extLst>
                </a:gridCol>
                <a:gridCol w="462641">
                  <a:extLst>
                    <a:ext uri="{9D8B030D-6E8A-4147-A177-3AD203B41FA5}">
                      <a16:colId xmlns:a16="http://schemas.microsoft.com/office/drawing/2014/main" val="1925397245"/>
                    </a:ext>
                  </a:extLst>
                </a:gridCol>
                <a:gridCol w="462641">
                  <a:extLst>
                    <a:ext uri="{9D8B030D-6E8A-4147-A177-3AD203B41FA5}">
                      <a16:colId xmlns:a16="http://schemas.microsoft.com/office/drawing/2014/main" val="1689343478"/>
                    </a:ext>
                  </a:extLst>
                </a:gridCol>
              </a:tblGrid>
              <a:tr h="177777">
                <a:tc>
                  <a:txBody>
                    <a:bodyPr/>
                    <a:lstStyle/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>
                          <a:effectLst/>
                        </a:rPr>
                        <a:t>TF Bin </a:t>
                      </a:r>
                      <a:endParaRPr lang="en-US" sz="400" b="0" i="0">
                        <a:effectLst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 i="0">
                          <a:effectLst/>
                        </a:rPr>
                        <a:t>Below LOQ (&lt;0.01%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 i="0">
                          <a:effectLst/>
                        </a:rPr>
                        <a:t>1</a:t>
                      </a:r>
                      <a:r>
                        <a:rPr lang="en-US" sz="400" b="0" i="0" baseline="30000">
                          <a:effectLst/>
                        </a:rPr>
                        <a:t>st</a:t>
                      </a:r>
                      <a:r>
                        <a:rPr lang="en-US" sz="400" b="0" i="0">
                          <a:effectLst/>
                        </a:rPr>
                        <a:t> Quartile </a:t>
                      </a:r>
                    </a:p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 i="0">
                          <a:effectLst/>
                        </a:rPr>
                        <a:t>(0.18%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 i="0">
                          <a:effectLst/>
                        </a:rPr>
                        <a:t>2</a:t>
                      </a:r>
                      <a:r>
                        <a:rPr lang="en-US" sz="400" b="0" i="0" baseline="30000">
                          <a:effectLst/>
                        </a:rPr>
                        <a:t>nd</a:t>
                      </a:r>
                      <a:r>
                        <a:rPr lang="en-US" sz="400" b="0" i="0">
                          <a:effectLst/>
                        </a:rPr>
                        <a:t> Quartile </a:t>
                      </a:r>
                    </a:p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 i="0">
                          <a:effectLst/>
                        </a:rPr>
                        <a:t>(1.29%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 i="0">
                          <a:effectLst/>
                        </a:rPr>
                        <a:t>3</a:t>
                      </a:r>
                      <a:r>
                        <a:rPr lang="en-US" sz="400" b="0" i="0" baseline="30000">
                          <a:effectLst/>
                        </a:rPr>
                        <a:t>rd</a:t>
                      </a:r>
                      <a:r>
                        <a:rPr lang="en-US" sz="400" b="0" i="0">
                          <a:effectLst/>
                        </a:rPr>
                        <a:t> Quartile </a:t>
                      </a:r>
                    </a:p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 i="0">
                          <a:effectLst/>
                        </a:rPr>
                        <a:t>(10.21%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 i="0">
                          <a:effectLst/>
                        </a:rPr>
                        <a:t>4</a:t>
                      </a:r>
                      <a:r>
                        <a:rPr lang="en-US" sz="400" b="0" i="0" baseline="30000">
                          <a:effectLst/>
                        </a:rPr>
                        <a:t>th</a:t>
                      </a:r>
                      <a:r>
                        <a:rPr lang="en-US" sz="400" b="0" i="0">
                          <a:effectLst/>
                        </a:rPr>
                        <a:t> Quartile (90.00%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2812678"/>
                  </a:ext>
                </a:extLst>
              </a:tr>
              <a:tr h="214629">
                <a:tc>
                  <a:txBody>
                    <a:bodyPr/>
                    <a:lstStyle/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>
                          <a:effectLst/>
                        </a:rPr>
                        <a:t>Median rwOS (95% CI)</a:t>
                      </a:r>
                      <a:endParaRPr lang="en-US" sz="400" b="0" i="0">
                        <a:effectLst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>
                          <a:effectLst/>
                        </a:rPr>
                        <a:t>NR </a:t>
                      </a:r>
                    </a:p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>
                          <a:effectLst/>
                        </a:rPr>
                        <a:t>[ NR,NR] </a:t>
                      </a:r>
                      <a:endParaRPr lang="en-US" sz="400" b="0" i="0">
                        <a:effectLst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>
                          <a:effectLst/>
                        </a:rPr>
                        <a:t>NR </a:t>
                      </a:r>
                    </a:p>
                    <a:p>
                      <a:pPr algn="ctr" rtl="0" fontAlgn="base">
                        <a:lnSpc>
                          <a:spcPct val="100000"/>
                        </a:lnSpc>
                      </a:pPr>
                      <a:r>
                        <a:rPr lang="en-US" sz="400" b="0">
                          <a:effectLst/>
                        </a:rPr>
                        <a:t>[ NR,NR] </a:t>
                      </a:r>
                      <a:endParaRPr lang="en-US" sz="400" b="0" i="0">
                        <a:effectLst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400" b="0">
                          <a:effectLst/>
                        </a:rPr>
                        <a:t>NR</a:t>
                      </a:r>
                    </a:p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400" b="0">
                          <a:effectLst/>
                        </a:rPr>
                        <a:t>[11.77,NR]</a:t>
                      </a:r>
                      <a:endParaRPr lang="en-US" sz="400" b="0" i="0">
                        <a:effectLst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400" b="0">
                          <a:effectLst/>
                        </a:rPr>
                        <a:t>9.4 </a:t>
                      </a:r>
                    </a:p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400" b="0">
                          <a:effectLst/>
                        </a:rPr>
                        <a:t>[7.70,13.40]</a:t>
                      </a:r>
                      <a:endParaRPr lang="en-US" sz="400" b="0" i="0">
                        <a:effectLst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400" b="0" i="0">
                          <a:effectLst/>
                        </a:rPr>
                        <a:t>7.27</a:t>
                      </a:r>
                    </a:p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400" b="0" i="0">
                          <a:effectLst/>
                        </a:rPr>
                        <a:t>[5.73,9.80]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8800230"/>
                  </a:ext>
                </a:extLst>
              </a:tr>
            </a:tbl>
          </a:graphicData>
        </a:graphic>
      </p:graphicFrame>
      <p:pic>
        <p:nvPicPr>
          <p:cNvPr id="13" name="Picture 12" descr="A graph of a number of patients with a number of months&#10;&#10;Description automatically generated">
            <a:extLst>
              <a:ext uri="{FF2B5EF4-FFF2-40B4-BE49-F238E27FC236}">
                <a16:creationId xmlns:a16="http://schemas.microsoft.com/office/drawing/2014/main" id="{8ED0375F-DC8D-C957-9B2E-054A4A2ADDA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3583" y="5518292"/>
            <a:ext cx="1559327" cy="1532364"/>
          </a:xfrm>
          <a:prstGeom prst="rect">
            <a:avLst/>
          </a:prstGeom>
        </p:spPr>
      </p:pic>
      <p:pic>
        <p:nvPicPr>
          <p:cNvPr id="15" name="Picture 14" descr="A graph of a number of patients with a number of months&#10;&#10;Description automatically generated">
            <a:extLst>
              <a:ext uri="{FF2B5EF4-FFF2-40B4-BE49-F238E27FC236}">
                <a16:creationId xmlns:a16="http://schemas.microsoft.com/office/drawing/2014/main" id="{FEE37963-872D-D1ED-DD50-4731786CEFE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97848" y="5518292"/>
            <a:ext cx="1559327" cy="1532364"/>
          </a:xfrm>
          <a:prstGeom prst="rect">
            <a:avLst/>
          </a:prstGeom>
        </p:spPr>
      </p:pic>
      <p:pic>
        <p:nvPicPr>
          <p:cNvPr id="17" name="Picture 16" descr="A graph of a number of patients with cancer&#10;&#10;Description automatically generated">
            <a:extLst>
              <a:ext uri="{FF2B5EF4-FFF2-40B4-BE49-F238E27FC236}">
                <a16:creationId xmlns:a16="http://schemas.microsoft.com/office/drawing/2014/main" id="{CAD78C6C-A70E-DCA8-81CE-B42FEF46F3C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82114" y="5518292"/>
            <a:ext cx="1559327" cy="1532364"/>
          </a:xfrm>
          <a:prstGeom prst="rect">
            <a:avLst/>
          </a:prstGeom>
        </p:spPr>
      </p:pic>
      <p:pic>
        <p:nvPicPr>
          <p:cNvPr id="19" name="Picture 18" descr="A graph of a log-rank and log-rank&#10;&#10;Description automatically generated">
            <a:extLst>
              <a:ext uri="{FF2B5EF4-FFF2-40B4-BE49-F238E27FC236}">
                <a16:creationId xmlns:a16="http://schemas.microsoft.com/office/drawing/2014/main" id="{94349F4B-4F69-3F8C-1E18-4EC6E6714DB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966380" y="5518292"/>
            <a:ext cx="1559327" cy="1532364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9A93A3F6-BA96-7E49-EB79-7F2A3089551F}"/>
              </a:ext>
            </a:extLst>
          </p:cNvPr>
          <p:cNvSpPr txBox="1"/>
          <p:nvPr/>
        </p:nvSpPr>
        <p:spPr>
          <a:xfrm>
            <a:off x="434462" y="486191"/>
            <a:ext cx="2680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1E4ECDB-7029-E620-5420-01DF123A47B4}"/>
              </a:ext>
            </a:extLst>
          </p:cNvPr>
          <p:cNvSpPr txBox="1"/>
          <p:nvPr/>
        </p:nvSpPr>
        <p:spPr>
          <a:xfrm>
            <a:off x="3382114" y="449421"/>
            <a:ext cx="2728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B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7018B90-E7B7-741D-9313-99153BAE737F}"/>
              </a:ext>
            </a:extLst>
          </p:cNvPr>
          <p:cNvSpPr txBox="1"/>
          <p:nvPr/>
        </p:nvSpPr>
        <p:spPr>
          <a:xfrm>
            <a:off x="509145" y="257544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F59F0E9-5A0B-3504-248F-A9E98103DBE7}"/>
              </a:ext>
            </a:extLst>
          </p:cNvPr>
          <p:cNvSpPr txBox="1"/>
          <p:nvPr/>
        </p:nvSpPr>
        <p:spPr>
          <a:xfrm>
            <a:off x="3460069" y="2517792"/>
            <a:ext cx="2744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D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0B57CCE-A01F-C070-7BAF-901A824417ED}"/>
              </a:ext>
            </a:extLst>
          </p:cNvPr>
          <p:cNvSpPr txBox="1"/>
          <p:nvPr/>
        </p:nvSpPr>
        <p:spPr>
          <a:xfrm>
            <a:off x="167968" y="5326592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AC300F9-430D-70AF-9028-D05563603639}"/>
              </a:ext>
            </a:extLst>
          </p:cNvPr>
          <p:cNvSpPr txBox="1"/>
          <p:nvPr/>
        </p:nvSpPr>
        <p:spPr>
          <a:xfrm>
            <a:off x="1851590" y="5326591"/>
            <a:ext cx="2632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F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DCBCEE4-1430-5EC1-449A-D9F7BB6306DD}"/>
              </a:ext>
            </a:extLst>
          </p:cNvPr>
          <p:cNvSpPr txBox="1"/>
          <p:nvPr/>
        </p:nvSpPr>
        <p:spPr>
          <a:xfrm>
            <a:off x="3439331" y="5330790"/>
            <a:ext cx="2632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G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DE74760-7B2C-691D-0D09-CCDB0B8B4425}"/>
              </a:ext>
            </a:extLst>
          </p:cNvPr>
          <p:cNvSpPr txBox="1"/>
          <p:nvPr/>
        </p:nvSpPr>
        <p:spPr>
          <a:xfrm>
            <a:off x="4955252" y="5326591"/>
            <a:ext cx="2632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H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638E4C8-1CA4-E81F-A256-C312B19D2224}"/>
              </a:ext>
            </a:extLst>
          </p:cNvPr>
          <p:cNvSpPr txBox="1"/>
          <p:nvPr/>
        </p:nvSpPr>
        <p:spPr>
          <a:xfrm>
            <a:off x="109694" y="7050656"/>
            <a:ext cx="6748306" cy="2092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effectLst/>
                <a:latin typeface="Helvetica Neue" panose="02000503000000020004" pitchFamily="2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3. Baseline TF detection is prognostic but TF change is predictive of outcome while on treatment in pan-solid tumor cohort (n=627) (A) Baseline Detection and Quantifiability Across Cancer Types (NSCLC = non-small cell lung cancer, SCLC = small cell lung cancer, RCC = renal cell carcinoma, MM = malignant melanoma, </a:t>
            </a:r>
            <a:r>
              <a:rPr lang="en-US" sz="1000" dirty="0" err="1">
                <a:solidFill>
                  <a:srgbClr val="000000"/>
                </a:solidFill>
                <a:effectLst/>
                <a:latin typeface="Helvetica Neue" panose="02000503000000020004" pitchFamily="2" charset="0"/>
                <a:ea typeface="Calibri" panose="020F0502020204030204" pitchFamily="34" charset="0"/>
                <a:cs typeface="Arial" panose="020B0604020202020204" pitchFamily="34" charset="0"/>
              </a:rPr>
              <a:t>BlC</a:t>
            </a:r>
            <a:r>
              <a:rPr lang="en-US" sz="1000" dirty="0">
                <a:solidFill>
                  <a:srgbClr val="000000"/>
                </a:solidFill>
                <a:effectLst/>
                <a:latin typeface="Helvetica Neue" panose="02000503000000020004" pitchFamily="2" charset="0"/>
                <a:ea typeface="Calibri" panose="020F0502020204030204" pitchFamily="34" charset="0"/>
                <a:cs typeface="Arial" panose="020B0604020202020204" pitchFamily="34" charset="0"/>
              </a:rPr>
              <a:t> = bladder cancer, HNSCC = head and neck squamous cell carcinoma, GE = gastroesophageal cancer, EC = endometrial cancer, CRC = colorectal cancer, PC = prostate cancer, </a:t>
            </a:r>
            <a:r>
              <a:rPr lang="en-US" sz="1000" dirty="0" err="1">
                <a:solidFill>
                  <a:srgbClr val="000000"/>
                </a:solidFill>
                <a:effectLst/>
                <a:latin typeface="Helvetica Neue" panose="02000503000000020004" pitchFamily="2" charset="0"/>
                <a:ea typeface="Calibri" panose="020F0502020204030204" pitchFamily="34" charset="0"/>
                <a:cs typeface="Arial" panose="020B0604020202020204" pitchFamily="34" charset="0"/>
              </a:rPr>
              <a:t>BrC</a:t>
            </a:r>
            <a:r>
              <a:rPr lang="en-US" sz="1000" dirty="0">
                <a:solidFill>
                  <a:srgbClr val="000000"/>
                </a:solidFill>
                <a:effectLst/>
                <a:latin typeface="Helvetica Neue" panose="02000503000000020004" pitchFamily="2" charset="0"/>
                <a:ea typeface="Calibri" panose="020F0502020204030204" pitchFamily="34" charset="0"/>
                <a:cs typeface="Arial" panose="020B0604020202020204" pitchFamily="34" charset="0"/>
              </a:rPr>
              <a:t> = breast cancer, MCC = Merkel cell carcinoma). Bar graph demonstrating the percentage of patients that had ctDNA detected by methylation in their pre-treatment plasma sample and the percentage whose samples were above the assay LOQ. Those without numbers are 100%.  (B) Box and whisker plot showing the distribution of baseline TF values by cancer type (C) Kaplan-Meier analysis showing the </a:t>
            </a:r>
            <a:r>
              <a:rPr lang="en-US" sz="1000" dirty="0" err="1">
                <a:solidFill>
                  <a:srgbClr val="000000"/>
                </a:solidFill>
                <a:effectLst/>
                <a:latin typeface="Helvetica Neue" panose="02000503000000020004" pitchFamily="2" charset="0"/>
                <a:ea typeface="Calibri" panose="020F0502020204030204" pitchFamily="34" charset="0"/>
                <a:cs typeface="Arial" panose="020B0604020202020204" pitchFamily="34" charset="0"/>
              </a:rPr>
              <a:t>rwPFS</a:t>
            </a:r>
            <a:r>
              <a:rPr lang="en-US" sz="1000" dirty="0">
                <a:solidFill>
                  <a:srgbClr val="000000"/>
                </a:solidFill>
                <a:effectLst/>
                <a:latin typeface="Helvetica Neue" panose="02000503000000020004" pitchFamily="2" charset="0"/>
                <a:ea typeface="Calibri" panose="020F0502020204030204" pitchFamily="34" charset="0"/>
                <a:cs typeface="Arial" panose="020B0604020202020204" pitchFamily="34" charset="0"/>
              </a:rPr>
              <a:t> (D)and </a:t>
            </a:r>
            <a:r>
              <a:rPr lang="en-US" sz="1000" dirty="0" err="1">
                <a:solidFill>
                  <a:srgbClr val="000000"/>
                </a:solidFill>
                <a:effectLst/>
                <a:latin typeface="Helvetica Neue" panose="02000503000000020004" pitchFamily="2" charset="0"/>
                <a:ea typeface="Calibri" panose="020F0502020204030204" pitchFamily="34" charset="0"/>
                <a:cs typeface="Arial" panose="020B0604020202020204" pitchFamily="34" charset="0"/>
              </a:rPr>
              <a:t>rwOS</a:t>
            </a:r>
            <a:r>
              <a:rPr lang="en-US" sz="1000" dirty="0">
                <a:solidFill>
                  <a:srgbClr val="000000"/>
                </a:solidFill>
                <a:effectLst/>
                <a:latin typeface="Helvetica Neue" panose="02000503000000020004" pitchFamily="2" charset="0"/>
                <a:ea typeface="Calibri" panose="020F0502020204030204" pitchFamily="34" charset="0"/>
                <a:cs typeface="Arial" panose="020B0604020202020204" pitchFamily="34" charset="0"/>
              </a:rPr>
              <a:t> for patients based on their baseline TF.  TF were binned as follows: ctDNA below LOQ (0, 0.01%), first quartile (0.18%), second quartile (1.29%), third quartile (10.21%), and fourth quartile (90.00%). (E-H) MR and </a:t>
            </a:r>
            <a:r>
              <a:rPr lang="en-US" sz="1000" dirty="0" err="1">
                <a:solidFill>
                  <a:srgbClr val="000000"/>
                </a:solidFill>
                <a:effectLst/>
                <a:latin typeface="Helvetica Neue" panose="02000503000000020004" pitchFamily="2" charset="0"/>
                <a:ea typeface="Calibri" panose="020F0502020204030204" pitchFamily="34" charset="0"/>
                <a:cs typeface="Arial" panose="020B0604020202020204" pitchFamily="34" charset="0"/>
              </a:rPr>
              <a:t>nMR</a:t>
            </a:r>
            <a:r>
              <a:rPr lang="en-US" sz="1000" dirty="0">
                <a:solidFill>
                  <a:srgbClr val="000000"/>
                </a:solidFill>
                <a:effectLst/>
                <a:latin typeface="Helvetica Neue" panose="02000503000000020004" pitchFamily="2" charset="0"/>
                <a:ea typeface="Calibri" panose="020F0502020204030204" pitchFamily="34" charset="0"/>
                <a:cs typeface="Arial" panose="020B0604020202020204" pitchFamily="34" charset="0"/>
              </a:rPr>
              <a:t> association with </a:t>
            </a:r>
            <a:r>
              <a:rPr lang="en-US" sz="1000" dirty="0" err="1">
                <a:solidFill>
                  <a:srgbClr val="000000"/>
                </a:solidFill>
                <a:effectLst/>
                <a:latin typeface="Helvetica Neue" panose="02000503000000020004" pitchFamily="2" charset="0"/>
                <a:ea typeface="Calibri" panose="020F0502020204030204" pitchFamily="34" charset="0"/>
                <a:cs typeface="Arial" panose="020B0604020202020204" pitchFamily="34" charset="0"/>
              </a:rPr>
              <a:t>rwPFS</a:t>
            </a:r>
            <a:r>
              <a:rPr lang="en-US" sz="1000" dirty="0">
                <a:solidFill>
                  <a:srgbClr val="000000"/>
                </a:solidFill>
                <a:effectLst/>
                <a:latin typeface="Helvetica Neue" panose="02000503000000020004" pitchFamily="2" charset="0"/>
                <a:ea typeface="Calibri" panose="020F0502020204030204" pitchFamily="34" charset="0"/>
                <a:cs typeface="Arial" panose="020B0604020202020204" pitchFamily="34" charset="0"/>
              </a:rPr>
              <a:t> by baseline quartile where (E) First quartile; TF=0.15% (F) Second quartile; TF=1.18% (G) Third quartile; TF=10.46% and (H) Fourth quartile; TF=90.0%. </a:t>
            </a:r>
            <a:endParaRPr lang="en-US" sz="10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432D97F-72D1-6FD8-6E3B-9CF684FD015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362689" y="224165"/>
            <a:ext cx="2891808" cy="239607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B00343B-6E85-9B30-50E0-F6E4A51A5F1C}"/>
              </a:ext>
            </a:extLst>
          </p:cNvPr>
          <p:cNvSpPr txBox="1"/>
          <p:nvPr/>
        </p:nvSpPr>
        <p:spPr>
          <a:xfrm>
            <a:off x="54838" y="36853"/>
            <a:ext cx="343614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Helvetica Neue" panose="02000503000000020004" pitchFamily="2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416068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7EAB79E8A649043B57FB7E201303455" ma:contentTypeVersion="14" ma:contentTypeDescription="Create a new document." ma:contentTypeScope="" ma:versionID="e71411c950fa83840c021bf03c814f63">
  <xsd:schema xmlns:xsd="http://www.w3.org/2001/XMLSchema" xmlns:xs="http://www.w3.org/2001/XMLSchema" xmlns:p="http://schemas.microsoft.com/office/2006/metadata/properties" xmlns:ns2="b0090abd-25aa-4ac3-b924-e35af8d9ed55" xmlns:ns3="606ae6eb-d705-4ce8-b671-b906251446a9" targetNamespace="http://schemas.microsoft.com/office/2006/metadata/properties" ma:root="true" ma:fieldsID="fa0abb8aea339e328f4d0d365659916b" ns2:_="" ns3:_="">
    <xsd:import namespace="b0090abd-25aa-4ac3-b924-e35af8d9ed55"/>
    <xsd:import namespace="606ae6eb-d705-4ce8-b671-b906251446a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0090abd-25aa-4ac3-b924-e35af8d9ed5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4" nillable="true" ma:taxonomy="true" ma:internalName="lcf76f155ced4ddcb4097134ff3c332f" ma:taxonomyFieldName="MediaServiceImageTags" ma:displayName="Image Tags" ma:readOnly="false" ma:fieldId="{5cf76f15-5ced-4ddc-b409-7134ff3c332f}" ma:taxonomyMulti="true" ma:sspId="a1d584be-b9fa-4213-aedc-5d44287790d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06ae6eb-d705-4ce8-b671-b906251446a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5" nillable="true" ma:displayName="Taxonomy Catch All Column" ma:hidden="true" ma:list="{d8541e83-b154-4cb1-97f5-e6365a08337c}" ma:internalName="TaxCatchAll" ma:showField="CatchAllData" ma:web="606ae6eb-d705-4ce8-b671-b906251446a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b0090abd-25aa-4ac3-b924-e35af8d9ed55">
      <Terms xmlns="http://schemas.microsoft.com/office/infopath/2007/PartnerControls"/>
    </lcf76f155ced4ddcb4097134ff3c332f>
    <TaxCatchAll xmlns="606ae6eb-d705-4ce8-b671-b906251446a9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CFDCDCFB-A19A-47C2-A857-5A1E61AC3829}">
  <ds:schemaRefs>
    <ds:schemaRef ds:uri="606ae6eb-d705-4ce8-b671-b906251446a9"/>
    <ds:schemaRef ds:uri="b0090abd-25aa-4ac3-b924-e35af8d9ed55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991CB7F9-EAA8-4639-93FB-092840FA0849}">
  <ds:schemaRefs>
    <ds:schemaRef ds:uri="b0090abd-25aa-4ac3-b924-e35af8d9ed55"/>
    <ds:schemaRef ds:uri="http://schemas.microsoft.com/office/2006/documentManagement/types"/>
    <ds:schemaRef ds:uri="http://purl.org/dc/elements/1.1/"/>
    <ds:schemaRef ds:uri="http://purl.org/dc/terms/"/>
    <ds:schemaRef ds:uri="http://schemas.microsoft.com/office/infopath/2007/PartnerControls"/>
    <ds:schemaRef ds:uri="606ae6eb-d705-4ce8-b671-b906251446a9"/>
    <ds:schemaRef ds:uri="http://schemas.microsoft.com/office/2006/metadata/properties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AF058950-C37C-4A99-A679-DB3B38A1AE72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77</TotalTime>
  <Words>401</Words>
  <Application>Microsoft Macintosh PowerPoint</Application>
  <PresentationFormat>Letter Paper (8.5x11 in)</PresentationFormat>
  <Paragraphs>5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Helvetica Neu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ra Wienke</dc:creator>
  <cp:lastModifiedBy>Samantha Liang</cp:lastModifiedBy>
  <cp:revision>14</cp:revision>
  <dcterms:created xsi:type="dcterms:W3CDTF">2024-12-13T18:22:33Z</dcterms:created>
  <dcterms:modified xsi:type="dcterms:W3CDTF">2025-07-09T17:19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7EAB79E8A649043B57FB7E201303455</vt:lpwstr>
  </property>
  <property fmtid="{D5CDD505-2E9C-101B-9397-08002B2CF9AE}" pid="3" name="MediaServiceImageTags">
    <vt:lpwstr/>
  </property>
</Properties>
</file>